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925973-DA31-4195-A6A3-83AFAD4245F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911550-7C48-42DC-AADD-EA0F8F2FF35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EE6B4-11EE-43F5-99C8-552A00D662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541798-EA9F-4153-B087-C853753460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5BB57-ADA9-4541-98D3-F3E48E6F2E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D8224-C260-4E49-8294-DD8E1DD3DC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8FDDC-E928-4CCD-AA84-B323CD7738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DD75B4-2B0B-4F66-9A2E-2FE7BDBCEF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CCF97-F1F4-47A7-8DA8-EDA461BCD9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7D31F3-852A-4716-BBD2-153E719B0D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75785-3DF5-4558-BECF-D2D204F5F9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185132-624E-41ED-8748-0F28BF3598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4D53B5-7ED9-40E7-8437-91A892CD9D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AB59E8-CB96-40E6-AA16-75D23E1F76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08B254-C4F0-40ED-8E40-7655EAD5321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1306440" y="1143000"/>
            <a:ext cx="4713480" cy="797868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336960" y="258840"/>
            <a:ext cx="6215760" cy="88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9 Unknown gene aligned with wheat ES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e unknown gene region matching barley ESTs is aligned with those ESTs. Base differences in the EST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mpared to the BAC sequence are in red. Canonical intron/exon junctions are shaded in blue. On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n-canonical junction is shaded in yellow. A segment where 17/18 bp matches the rice genome in the sam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lative position to the wheat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LKR/SDH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gene is bracketed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5T00:13:25Z</dcterms:created>
  <dc:creator> </dc:creator>
  <dc:description/>
  <dc:language>en-US</dc:language>
  <cp:lastModifiedBy>Office 2003 Registered User</cp:lastModifiedBy>
  <dcterms:modified xsi:type="dcterms:W3CDTF">2010-05-18T22:47:11Z</dcterms:modified>
  <cp:revision>2</cp:revision>
  <dc:subject/>
  <dc:title>Slide 1</dc:title>
</cp:coreProperties>
</file>